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6000" y="-360"/>
            <a:ext cx="2917800" cy="49356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81080" y="740880"/>
            <a:ext cx="2773440" cy="369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024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4040"/>
            <a:ext cx="2919240" cy="49392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6000" y="9374040"/>
            <a:ext cx="2917800" cy="493920"/>
          </a:xfrm>
          <a:prstGeom prst="rect">
            <a:avLst/>
          </a:prstGeom>
          <a:noFill/>
          <a:ln w="0">
            <a:noFill/>
          </a:ln>
        </p:spPr>
        <p:txBody>
          <a:bodyPr lIns="90720" rIns="90720" tIns="45360" bIns="45360" anchor="b">
            <a:noAutofit/>
          </a:bodyPr>
          <a:lstStyle>
            <a:lvl1pPr indent="0" algn="r">
              <a:buNone/>
              <a:tabLst>
                <a:tab algn="l" pos="0"/>
                <a:tab algn="l" pos="905040"/>
                <a:tab algn="l" pos="1809720"/>
                <a:tab algn="l" pos="2714760"/>
                <a:tab algn="l" pos="3619440"/>
                <a:tab algn="l" pos="4524480"/>
                <a:tab algn="l" pos="5429160"/>
                <a:tab algn="l" pos="6334200"/>
                <a:tab algn="l" pos="7238880"/>
                <a:tab algn="l" pos="8143920"/>
                <a:tab algn="l" pos="9048600"/>
                <a:tab algn="l" pos="9953640"/>
                <a:tab algn="l" pos="108586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05040"/>
                <a:tab algn="l" pos="1809720"/>
                <a:tab algn="l" pos="2714760"/>
                <a:tab algn="l" pos="3619440"/>
                <a:tab algn="l" pos="4524480"/>
                <a:tab algn="l" pos="5429160"/>
                <a:tab algn="l" pos="6334200"/>
                <a:tab algn="l" pos="7238880"/>
                <a:tab algn="l" pos="8143920"/>
                <a:tab algn="l" pos="9048600"/>
                <a:tab algn="l" pos="9953640"/>
                <a:tab algn="l" pos="10858680"/>
              </a:tabLst>
            </a:pPr>
            <a:fld id="{925DDDE7-A7CB-4218-AFE7-11CE6D41250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981080" y="741240"/>
            <a:ext cx="2773440" cy="369900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72840" y="4687920"/>
            <a:ext cx="5389560" cy="4440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スライド番号プレースホルダ 3"/>
          <p:cNvSpPr/>
          <p:nvPr/>
        </p:nvSpPr>
        <p:spPr>
          <a:xfrm>
            <a:off x="3816360" y="9374040"/>
            <a:ext cx="291780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720" rIns="90720" tIns="45360" bIns="45360" anchor="b">
            <a:noAutofit/>
          </a:bodyPr>
          <a:p>
            <a:pPr algn="r">
              <a:tabLst>
                <a:tab algn="l" pos="0"/>
                <a:tab algn="l" pos="903240"/>
                <a:tab algn="l" pos="1806480"/>
                <a:tab algn="l" pos="2709720"/>
                <a:tab algn="l" pos="3613320"/>
                <a:tab algn="l" pos="4516560"/>
                <a:tab algn="l" pos="5419800"/>
                <a:tab algn="l" pos="6323040"/>
                <a:tab algn="l" pos="7226280"/>
                <a:tab algn="l" pos="8129520"/>
                <a:tab algn="l" pos="9032760"/>
                <a:tab algn="l" pos="9936000"/>
                <a:tab algn="l" pos="10839600"/>
              </a:tabLst>
            </a:pPr>
            <a:fld id="{0E516C29-B4B4-4855-B8B3-8737D373682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1BEE4-4606-4669-AF51-73ECA47C1A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3F4C2-F105-41A3-B31B-A4F907D33C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964B6-F32D-484E-B822-C6D1E546B2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56CFF-9450-4569-AE1B-EC07F5AA90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6FAF3-D124-41F3-A526-079B47AEBB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CCC7A-45FD-4A50-BA7D-2D4621A3D7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CFEEB-EA6B-4B87-9587-14DEA05156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56FA3-6AFC-4684-B23F-EABB7E8374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56A8A-4EC7-4AA7-82A0-8C3D735579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C4DEE-FC07-4ED6-81A1-6FB7AD4DA7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479B0-7CC3-42D3-A398-154806781B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65EC6-097D-4564-A3E3-577DD687C5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8117A2-208D-4B26-AAA9-F0D5FB03DCC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" descr=""/>
          <p:cNvPicPr/>
          <p:nvPr/>
        </p:nvPicPr>
        <p:blipFill>
          <a:blip r:embed="rId1"/>
          <a:stretch/>
        </p:blipFill>
        <p:spPr>
          <a:xfrm>
            <a:off x="828720" y="5718240"/>
            <a:ext cx="2554200" cy="2041560"/>
          </a:xfrm>
          <a:prstGeom prst="rect">
            <a:avLst/>
          </a:prstGeom>
          <a:ln w="0">
            <a:noFill/>
          </a:ln>
        </p:spPr>
      </p:pic>
      <p:pic>
        <p:nvPicPr>
          <p:cNvPr id="49" name="Chart 4" descr=""/>
          <p:cNvPicPr/>
          <p:nvPr/>
        </p:nvPicPr>
        <p:blipFill>
          <a:blip r:embed="rId2"/>
          <a:stretch/>
        </p:blipFill>
        <p:spPr>
          <a:xfrm>
            <a:off x="3638520" y="5572080"/>
            <a:ext cx="2603520" cy="23655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2" descr="C:\Users\oka-lab users\Documents\h_fukuda\wild CXCL12 1.8.jpg"/>
          <p:cNvPicPr/>
          <p:nvPr/>
        </p:nvPicPr>
        <p:blipFill>
          <a:blip r:embed="rId3"/>
          <a:srcRect l="13665" t="0" r="28600" b="0"/>
          <a:stretch/>
        </p:blipFill>
        <p:spPr>
          <a:xfrm>
            <a:off x="2104920" y="1273320"/>
            <a:ext cx="2708280" cy="345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C:\Users\oka-lab users\Documents\h_fukuda\13KO βactin3.12.jpg"/>
          <p:cNvPicPr/>
          <p:nvPr/>
        </p:nvPicPr>
        <p:blipFill>
          <a:blip r:embed="rId4"/>
          <a:srcRect l="14430" t="0" r="27417" b="0"/>
          <a:stretch/>
        </p:blipFill>
        <p:spPr>
          <a:xfrm>
            <a:off x="2133720" y="4140360"/>
            <a:ext cx="2735280" cy="360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C:\Users\oka-lab users\Documents\h_fukuda\wild βactin3.11.jpg"/>
          <p:cNvPicPr/>
          <p:nvPr/>
        </p:nvPicPr>
        <p:blipFill>
          <a:blip r:embed="rId5"/>
          <a:srcRect l="14430" t="0" r="28448" b="0"/>
          <a:stretch/>
        </p:blipFill>
        <p:spPr>
          <a:xfrm>
            <a:off x="2104920" y="2195640"/>
            <a:ext cx="2705040" cy="3873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4" descr="C:\Users\oka-lab users\Documents\h_fukuda\SDF-1 MMP13KO-3020.jpg"/>
          <p:cNvPicPr/>
          <p:nvPr/>
        </p:nvPicPr>
        <p:blipFill>
          <a:blip r:embed="rId6"/>
          <a:srcRect l="1983" t="0" r="32527" b="0"/>
          <a:stretch/>
        </p:blipFill>
        <p:spPr>
          <a:xfrm>
            <a:off x="2127240" y="3236760"/>
            <a:ext cx="2739960" cy="360360"/>
          </a:xfrm>
          <a:prstGeom prst="rect">
            <a:avLst/>
          </a:prstGeom>
          <a:ln w="0">
            <a:noFill/>
          </a:ln>
        </p:spPr>
      </p:pic>
      <p:sp>
        <p:nvSpPr>
          <p:cNvPr id="54" name="テキスト ボックス 11"/>
          <p:cNvSpPr/>
          <p:nvPr/>
        </p:nvSpPr>
        <p:spPr>
          <a:xfrm>
            <a:off x="1344600" y="1324080"/>
            <a:ext cx="103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DF-1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9"/>
          <p:cNvSpPr/>
          <p:nvPr/>
        </p:nvSpPr>
        <p:spPr>
          <a:xfrm>
            <a:off x="1344600" y="2266920"/>
            <a:ext cx="95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5"/>
          <p:cNvSpPr/>
          <p:nvPr/>
        </p:nvSpPr>
        <p:spPr>
          <a:xfrm>
            <a:off x="2205000" y="922320"/>
            <a:ext cx="72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5"/>
          <p:cNvSpPr/>
          <p:nvPr/>
        </p:nvSpPr>
        <p:spPr>
          <a:xfrm>
            <a:off x="2852640" y="92232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y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5"/>
          <p:cNvSpPr/>
          <p:nvPr/>
        </p:nvSpPr>
        <p:spPr>
          <a:xfrm>
            <a:off x="3500280" y="92232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y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1"/>
          <p:cNvSpPr/>
          <p:nvPr/>
        </p:nvSpPr>
        <p:spPr>
          <a:xfrm>
            <a:off x="1365120" y="3294000"/>
            <a:ext cx="103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DF-1α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19"/>
          <p:cNvSpPr/>
          <p:nvPr/>
        </p:nvSpPr>
        <p:spPr>
          <a:xfrm>
            <a:off x="1379520" y="4197240"/>
            <a:ext cx="95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5"/>
          <p:cNvSpPr/>
          <p:nvPr/>
        </p:nvSpPr>
        <p:spPr>
          <a:xfrm>
            <a:off x="4149720" y="9223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y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4"/>
          <p:cNvSpPr/>
          <p:nvPr/>
        </p:nvSpPr>
        <p:spPr>
          <a:xfrm>
            <a:off x="1989000" y="530532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u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5"/>
          <p:cNvSpPr/>
          <p:nvPr/>
        </p:nvSpPr>
        <p:spPr>
          <a:xfrm>
            <a:off x="4653000" y="5305320"/>
            <a:ext cx="100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u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6"/>
          <p:cNvSpPr/>
          <p:nvPr/>
        </p:nvSpPr>
        <p:spPr>
          <a:xfrm>
            <a:off x="144360" y="606600"/>
            <a:ext cx="40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7"/>
          <p:cNvSpPr/>
          <p:nvPr/>
        </p:nvSpPr>
        <p:spPr>
          <a:xfrm>
            <a:off x="144360" y="4710240"/>
            <a:ext cx="40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8"/>
          <p:cNvSpPr/>
          <p:nvPr/>
        </p:nvSpPr>
        <p:spPr>
          <a:xfrm>
            <a:off x="-3240" y="108000"/>
            <a:ext cx="2711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5"/>
          <p:cNvSpPr/>
          <p:nvPr/>
        </p:nvSpPr>
        <p:spPr>
          <a:xfrm>
            <a:off x="547560" y="816120"/>
            <a:ext cx="936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T</a:t>
            </a:r>
            <a:r>
              <a:rPr b="0" lang="ja-JP" sz="2400" spc="-1" strike="noStrike">
                <a:solidFill>
                  <a:srgbClr val="000000"/>
                </a:solidFill>
                <a:latin typeface="Arial"/>
              </a:rPr>
              <a:t>　　　　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5"/>
          <p:cNvSpPr/>
          <p:nvPr/>
        </p:nvSpPr>
        <p:spPr>
          <a:xfrm>
            <a:off x="547560" y="2801880"/>
            <a:ext cx="1225800" cy="103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MP-13 KO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　　</a:t>
            </a:r>
            <a:r>
              <a:rPr b="0" lang="ja-JP" sz="2400" spc="-1" strike="noStrike">
                <a:solidFill>
                  <a:srgbClr val="000000"/>
                </a:solidFill>
                <a:latin typeface="Arial"/>
              </a:rPr>
              <a:t>　　　　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9"/>
          <p:cNvSpPr/>
          <p:nvPr/>
        </p:nvSpPr>
        <p:spPr>
          <a:xfrm rot="16200000">
            <a:off x="2903040" y="6576120"/>
            <a:ext cx="124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F-1α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n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"/>
          <p:cNvSpPr/>
          <p:nvPr/>
        </p:nvSpPr>
        <p:spPr>
          <a:xfrm rot="16200000">
            <a:off x="14400" y="6467400"/>
            <a:ext cx="14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F-1α</a:t>
            </a: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ng/m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5"/>
          <p:cNvSpPr/>
          <p:nvPr/>
        </p:nvSpPr>
        <p:spPr>
          <a:xfrm>
            <a:off x="1125360" y="7524720"/>
            <a:ext cx="721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5"/>
          <p:cNvSpPr/>
          <p:nvPr/>
        </p:nvSpPr>
        <p:spPr>
          <a:xfrm>
            <a:off x="227664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5"/>
          <p:cNvSpPr/>
          <p:nvPr/>
        </p:nvSpPr>
        <p:spPr>
          <a:xfrm>
            <a:off x="285264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5"/>
          <p:cNvSpPr/>
          <p:nvPr/>
        </p:nvSpPr>
        <p:spPr>
          <a:xfrm>
            <a:off x="170028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5"/>
          <p:cNvSpPr/>
          <p:nvPr/>
        </p:nvSpPr>
        <p:spPr>
          <a:xfrm>
            <a:off x="393372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5"/>
          <p:cNvSpPr/>
          <p:nvPr/>
        </p:nvSpPr>
        <p:spPr>
          <a:xfrm>
            <a:off x="508464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5"/>
          <p:cNvSpPr/>
          <p:nvPr/>
        </p:nvSpPr>
        <p:spPr>
          <a:xfrm>
            <a:off x="566100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5"/>
          <p:cNvSpPr/>
          <p:nvPr/>
        </p:nvSpPr>
        <p:spPr>
          <a:xfrm>
            <a:off x="4508640" y="75247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ay 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2" descr="C:\Users\oka-lab users\Documents\h_fukuda\CXCR4 1.13 .jpg"/>
          <p:cNvPicPr/>
          <p:nvPr/>
        </p:nvPicPr>
        <p:blipFill>
          <a:blip r:embed="rId7"/>
          <a:srcRect l="14103" t="0" r="28833" b="0"/>
          <a:stretch/>
        </p:blipFill>
        <p:spPr>
          <a:xfrm>
            <a:off x="2104920" y="1704960"/>
            <a:ext cx="2708280" cy="419040"/>
          </a:xfrm>
          <a:prstGeom prst="rect">
            <a:avLst/>
          </a:prstGeom>
          <a:ln w="0">
            <a:noFill/>
          </a:ln>
        </p:spPr>
      </p:pic>
      <p:sp>
        <p:nvSpPr>
          <p:cNvPr id="80" name="テキスト ボックス 14"/>
          <p:cNvSpPr/>
          <p:nvPr/>
        </p:nvSpPr>
        <p:spPr>
          <a:xfrm>
            <a:off x="1341360" y="1768320"/>
            <a:ext cx="103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XCR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3" descr="C:\Users\oka-lab users\Documents\h_fukuda\CXCR4 13KO 1.13 -.jpg"/>
          <p:cNvPicPr/>
          <p:nvPr/>
        </p:nvPicPr>
        <p:blipFill>
          <a:blip r:embed="rId8"/>
          <a:srcRect l="14317" t="0" r="27679" b="0"/>
          <a:stretch/>
        </p:blipFill>
        <p:spPr>
          <a:xfrm>
            <a:off x="2125800" y="3678120"/>
            <a:ext cx="2730240" cy="389160"/>
          </a:xfrm>
          <a:prstGeom prst="rect">
            <a:avLst/>
          </a:prstGeom>
          <a:ln w="0">
            <a:noFill/>
          </a:ln>
        </p:spPr>
      </p:pic>
      <p:sp>
        <p:nvSpPr>
          <p:cNvPr id="82" name="テキスト ボックス 14"/>
          <p:cNvSpPr/>
          <p:nvPr/>
        </p:nvSpPr>
        <p:spPr>
          <a:xfrm>
            <a:off x="1366920" y="3749760"/>
            <a:ext cx="103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XCR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1"/>
          <p:cNvSpPr/>
          <p:nvPr/>
        </p:nvSpPr>
        <p:spPr>
          <a:xfrm>
            <a:off x="4629240" y="5864400"/>
            <a:ext cx="106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MP-13 K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正方形/長方形 42"/>
          <p:cNvSpPr/>
          <p:nvPr/>
        </p:nvSpPr>
        <p:spPr>
          <a:xfrm>
            <a:off x="4605480" y="5797440"/>
            <a:ext cx="55440" cy="54000"/>
          </a:xfrm>
          <a:prstGeom prst="rect">
            <a:avLst/>
          </a:prstGeom>
          <a:noFill/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正方形/長方形 43"/>
          <p:cNvSpPr/>
          <p:nvPr/>
        </p:nvSpPr>
        <p:spPr>
          <a:xfrm>
            <a:off x="4508640" y="5724360"/>
            <a:ext cx="912600" cy="358920"/>
          </a:xfrm>
          <a:prstGeom prst="rect">
            <a:avLst/>
          </a:prstGeom>
          <a:noFill/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3"/>
          <p:cNvSpPr/>
          <p:nvPr/>
        </p:nvSpPr>
        <p:spPr>
          <a:xfrm>
            <a:off x="4653000" y="5700600"/>
            <a:ext cx="1049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正方形/長方形 47"/>
          <p:cNvSpPr/>
          <p:nvPr/>
        </p:nvSpPr>
        <p:spPr>
          <a:xfrm flipV="1">
            <a:off x="4605480" y="5962680"/>
            <a:ext cx="55440" cy="55440"/>
          </a:xfrm>
          <a:prstGeom prst="rect">
            <a:avLst/>
          </a:prstGeom>
          <a:solidFill>
            <a:srgbClr val="0d0d0d"/>
          </a:solidFill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1"/>
          <p:cNvSpPr/>
          <p:nvPr/>
        </p:nvSpPr>
        <p:spPr>
          <a:xfrm>
            <a:off x="1820880" y="5864400"/>
            <a:ext cx="106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MP-13 K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正方形/長方形 49"/>
          <p:cNvSpPr/>
          <p:nvPr/>
        </p:nvSpPr>
        <p:spPr>
          <a:xfrm>
            <a:off x="1797120" y="5797440"/>
            <a:ext cx="55440" cy="54000"/>
          </a:xfrm>
          <a:prstGeom prst="rect">
            <a:avLst/>
          </a:prstGeom>
          <a:noFill/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正方形/長方形 50"/>
          <p:cNvSpPr/>
          <p:nvPr/>
        </p:nvSpPr>
        <p:spPr>
          <a:xfrm>
            <a:off x="1700280" y="5724360"/>
            <a:ext cx="912600" cy="358920"/>
          </a:xfrm>
          <a:prstGeom prst="rect">
            <a:avLst/>
          </a:prstGeom>
          <a:noFill/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3"/>
          <p:cNvSpPr/>
          <p:nvPr/>
        </p:nvSpPr>
        <p:spPr>
          <a:xfrm>
            <a:off x="1844640" y="5700600"/>
            <a:ext cx="1049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52"/>
          <p:cNvSpPr/>
          <p:nvPr/>
        </p:nvSpPr>
        <p:spPr>
          <a:xfrm flipV="1">
            <a:off x="1797120" y="5962680"/>
            <a:ext cx="55440" cy="55440"/>
          </a:xfrm>
          <a:prstGeom prst="rect">
            <a:avLst/>
          </a:prstGeom>
          <a:solidFill>
            <a:srgbClr val="0d0d0d"/>
          </a:solidFill>
          <a:ln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00:56:52Z</dcterms:created>
  <dc:creator>福田　祐樹</dc:creator>
  <dc:description/>
  <dc:language>en-US</dc:language>
  <cp:lastModifiedBy>j.jagadheesh</cp:lastModifiedBy>
  <cp:lastPrinted>2011-02-28T03:57:28Z</cp:lastPrinted>
  <dcterms:modified xsi:type="dcterms:W3CDTF">2011-10-15T16:02:55Z</dcterms:modified>
  <cp:revision>415</cp:revision>
  <dc:subject/>
  <dc:title>スライド 1</dc:title>
</cp:coreProperties>
</file>